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58" d="100"/>
          <a:sy n="58" d="100"/>
        </p:scale>
        <p:origin x="108" y="5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Ito Renma" userId="828e3e6a6622ec32" providerId="LiveId" clId="{B7116DDB-6344-4371-800B-AE4825B8F565}"/>
    <pc:docChg chg="undo custSel modSld">
      <pc:chgData name="Ito Renma" userId="828e3e6a6622ec32" providerId="LiveId" clId="{B7116DDB-6344-4371-800B-AE4825B8F565}" dt="2022-05-12T07:31:05.276" v="49" actId="20577"/>
      <pc:docMkLst>
        <pc:docMk/>
      </pc:docMkLst>
      <pc:sldChg chg="modSp mod">
        <pc:chgData name="Ito Renma" userId="828e3e6a6622ec32" providerId="LiveId" clId="{B7116DDB-6344-4371-800B-AE4825B8F565}" dt="2022-05-12T07:31:05.276" v="49" actId="20577"/>
        <pc:sldMkLst>
          <pc:docMk/>
          <pc:sldMk cId="788297579" sldId="276"/>
        </pc:sldMkLst>
        <pc:graphicFrameChg chg="modGraphic">
          <ac:chgData name="Ito Renma" userId="828e3e6a6622ec32" providerId="LiveId" clId="{B7116DDB-6344-4371-800B-AE4825B8F565}" dt="2022-05-12T07:31:05.276" v="49" actId="20577"/>
          <ac:graphicFrameMkLst>
            <pc:docMk/>
            <pc:sldMk cId="788297579" sldId="276"/>
            <ac:graphicFrameMk id="3" creationId="{C2AFDA87-8B20-4AAA-A1B4-360514E81052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B87A459-F01A-4F80-AFCF-BE8C6A0CD1E0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8C489EF-8FBD-4388-A1E3-B8B523A7A17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10741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D1D16-DC56-4ACA-AC8A-8C83A969A572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902E2-D84D-4E95-B0D1-34D8BF5D83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37520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D1D16-DC56-4ACA-AC8A-8C83A969A572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902E2-D84D-4E95-B0D1-34D8BF5D83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4345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D1D16-DC56-4ACA-AC8A-8C83A969A572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902E2-D84D-4E95-B0D1-34D8BF5D83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22380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D1D16-DC56-4ACA-AC8A-8C83A969A572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902E2-D84D-4E95-B0D1-34D8BF5D83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78602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D1D16-DC56-4ACA-AC8A-8C83A969A572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902E2-D84D-4E95-B0D1-34D8BF5D83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43711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D1D16-DC56-4ACA-AC8A-8C83A969A572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902E2-D84D-4E95-B0D1-34D8BF5D83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8747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D1D16-DC56-4ACA-AC8A-8C83A969A572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902E2-D84D-4E95-B0D1-34D8BF5D83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26785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D1D16-DC56-4ACA-AC8A-8C83A969A572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902E2-D84D-4E95-B0D1-34D8BF5D83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77079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D1D16-DC56-4ACA-AC8A-8C83A969A572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902E2-D84D-4E95-B0D1-34D8BF5D83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773615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D1D16-DC56-4ACA-AC8A-8C83A969A572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902E2-D84D-4E95-B0D1-34D8BF5D83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92845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0D1D16-DC56-4ACA-AC8A-8C83A969A572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902E2-D84D-4E95-B0D1-34D8BF5D83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64443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0D1D16-DC56-4ACA-AC8A-8C83A969A572}" type="datetimeFigureOut">
              <a:rPr kumimoji="1" lang="ja-JP" altLang="en-US" smtClean="0"/>
              <a:t>2022/5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E902E2-D84D-4E95-B0D1-34D8BF5D83B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6611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A4FAFE8D-D502-4182-B568-E2EADB82F4A4}"/>
              </a:ext>
            </a:extLst>
          </p:cNvPr>
          <p:cNvSpPr txBox="1"/>
          <p:nvPr/>
        </p:nvSpPr>
        <p:spPr>
          <a:xfrm>
            <a:off x="258792" y="161660"/>
            <a:ext cx="1062983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1. Outcomes of concurrent chemoradiotherapy for postoperative locoregional recurrence of </a:t>
            </a:r>
          </a:p>
          <a:p>
            <a:r>
              <a:rPr kumimoji="1" lang="en-US" altLang="ja-JP"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                    esophageal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quamous</a:t>
            </a:r>
            <a:r>
              <a:rPr lang="ja-JP" alt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 carcinoma in </a:t>
            </a:r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vious studies of more than 20 cases  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3" name="表 3">
            <a:extLst>
              <a:ext uri="{FF2B5EF4-FFF2-40B4-BE49-F238E27FC236}">
                <a16:creationId xmlns:a16="http://schemas.microsoft.com/office/drawing/2014/main" id="{C2AFDA87-8B20-4AAA-A1B4-360514E8105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07758840"/>
              </p:ext>
            </p:extLst>
          </p:nvPr>
        </p:nvGraphicFramePr>
        <p:xfrm>
          <a:off x="37578" y="1532360"/>
          <a:ext cx="12112667" cy="407924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90181">
                  <a:extLst>
                    <a:ext uri="{9D8B030D-6E8A-4147-A177-3AD203B41FA5}">
                      <a16:colId xmlns:a16="http://schemas.microsoft.com/office/drawing/2014/main" val="916733968"/>
                    </a:ext>
                  </a:extLst>
                </a:gridCol>
                <a:gridCol w="594347">
                  <a:extLst>
                    <a:ext uri="{9D8B030D-6E8A-4147-A177-3AD203B41FA5}">
                      <a16:colId xmlns:a16="http://schemas.microsoft.com/office/drawing/2014/main" val="3364559468"/>
                    </a:ext>
                  </a:extLst>
                </a:gridCol>
                <a:gridCol w="447870">
                  <a:extLst>
                    <a:ext uri="{9D8B030D-6E8A-4147-A177-3AD203B41FA5}">
                      <a16:colId xmlns:a16="http://schemas.microsoft.com/office/drawing/2014/main" val="3815258567"/>
                    </a:ext>
                  </a:extLst>
                </a:gridCol>
                <a:gridCol w="2030574">
                  <a:extLst>
                    <a:ext uri="{9D8B030D-6E8A-4147-A177-3AD203B41FA5}">
                      <a16:colId xmlns:a16="http://schemas.microsoft.com/office/drawing/2014/main" val="2212956079"/>
                    </a:ext>
                  </a:extLst>
                </a:gridCol>
                <a:gridCol w="1409700">
                  <a:extLst>
                    <a:ext uri="{9D8B030D-6E8A-4147-A177-3AD203B41FA5}">
                      <a16:colId xmlns:a16="http://schemas.microsoft.com/office/drawing/2014/main" val="3876403255"/>
                    </a:ext>
                  </a:extLst>
                </a:gridCol>
                <a:gridCol w="1771650">
                  <a:extLst>
                    <a:ext uri="{9D8B030D-6E8A-4147-A177-3AD203B41FA5}">
                      <a16:colId xmlns:a16="http://schemas.microsoft.com/office/drawing/2014/main" val="1163967375"/>
                    </a:ext>
                  </a:extLst>
                </a:gridCol>
                <a:gridCol w="1628775">
                  <a:extLst>
                    <a:ext uri="{9D8B030D-6E8A-4147-A177-3AD203B41FA5}">
                      <a16:colId xmlns:a16="http://schemas.microsoft.com/office/drawing/2014/main" val="3528365207"/>
                    </a:ext>
                  </a:extLst>
                </a:gridCol>
                <a:gridCol w="1628775">
                  <a:extLst>
                    <a:ext uri="{9D8B030D-6E8A-4147-A177-3AD203B41FA5}">
                      <a16:colId xmlns:a16="http://schemas.microsoft.com/office/drawing/2014/main" val="2313039009"/>
                    </a:ext>
                  </a:extLst>
                </a:gridCol>
                <a:gridCol w="1310795">
                  <a:extLst>
                    <a:ext uri="{9D8B030D-6E8A-4147-A177-3AD203B41FA5}">
                      <a16:colId xmlns:a16="http://schemas.microsoft.com/office/drawing/2014/main" val="870322380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5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rst author</a:t>
                      </a:r>
                      <a:endParaRPr kumimoji="1" lang="ja-JP" altLang="en-US" sz="1500" b="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5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ear</a:t>
                      </a:r>
                      <a:endParaRPr kumimoji="1" lang="ja-JP" altLang="en-US" sz="1500" b="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5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o.</a:t>
                      </a:r>
                      <a:endParaRPr kumimoji="1" lang="ja-JP" altLang="en-US" sz="1500" b="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5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emotherapy regimen</a:t>
                      </a:r>
                      <a:endParaRPr kumimoji="1" lang="ja-JP" altLang="en-US" sz="1500" b="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5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D or 3D-CRT</a:t>
                      </a:r>
                      <a:endParaRPr kumimoji="1" lang="ja-JP" altLang="en-US" sz="1500" b="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5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diation dose (</a:t>
                      </a:r>
                      <a:r>
                        <a:rPr kumimoji="1" lang="en-US" altLang="ja-JP" sz="1500" b="0" baseline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y</a:t>
                      </a:r>
                      <a:r>
                        <a:rPr kumimoji="1" lang="en-US" altLang="ja-JP" sz="15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kumimoji="1" lang="ja-JP" altLang="en-US" sz="1500" b="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5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esponse rate (%)</a:t>
                      </a:r>
                      <a:endParaRPr kumimoji="1" lang="ja-JP" altLang="en-US" sz="1500" b="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5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-year OS rate (%)</a:t>
                      </a:r>
                      <a:endParaRPr kumimoji="1" lang="ja-JP" altLang="en-US" sz="1500" b="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500" b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ST (months)</a:t>
                      </a:r>
                      <a:endParaRPr kumimoji="1" lang="ja-JP" altLang="en-US" sz="1500" b="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1884593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kamura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08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P or FN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D-CRT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-66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3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6.6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3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0475990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u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0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P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D-CRT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5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0385472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ruyama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1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P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D-CRT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-68.8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953011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600" baseline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Jingu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2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N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D-CRT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2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8.4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7910514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hang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2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P or PTX+CDDP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D-CRT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0.4-64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2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3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2457062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ao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3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3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P or DOC+CDDP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D-CRT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-68 or 40-54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5.9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.8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9082654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obayashi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4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P or NDP+S1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D-CRT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.6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1.1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3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1547486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4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9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DP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D-CRT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2-70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.8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6.9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3047899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awamoto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17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7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P or DOC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D or 3D-CRT 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-66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2.5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.5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</a:t>
                      </a:r>
                      <a:endParaRPr kumimoji="1" lang="ja-JP" altLang="en-US" sz="16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519852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sent study</a:t>
                      </a:r>
                      <a:endParaRPr kumimoji="1" lang="ja-JP" altLang="en-US" sz="160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20</a:t>
                      </a:r>
                      <a:endParaRPr kumimoji="1" lang="ja-JP" altLang="en-US" sz="160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</a:t>
                      </a:r>
                      <a:endParaRPr kumimoji="1" lang="ja-JP" altLang="en-US" sz="160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P or FN</a:t>
                      </a:r>
                      <a:endParaRPr kumimoji="1" lang="ja-JP" altLang="en-US" sz="160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D-CRT</a:t>
                      </a:r>
                      <a:endParaRPr kumimoji="1" lang="ja-JP" altLang="en-US" sz="160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0</a:t>
                      </a:r>
                      <a:endParaRPr kumimoji="1" lang="ja-JP" altLang="en-US" sz="160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4.5</a:t>
                      </a:r>
                      <a:endParaRPr kumimoji="1" lang="ja-JP" altLang="en-US" sz="160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.7</a:t>
                      </a:r>
                      <a:endParaRPr kumimoji="1" lang="ja-JP" altLang="en-US" sz="160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16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.1</a:t>
                      </a:r>
                      <a:endParaRPr kumimoji="1" lang="ja-JP" altLang="en-US" sz="160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52019790"/>
                  </a:ext>
                </a:extLst>
              </a:tr>
            </a:tbl>
          </a:graphicData>
        </a:graphic>
      </p:graphicFrame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039B69C-54D9-450C-A216-44CE89EBC6BD}"/>
              </a:ext>
            </a:extLst>
          </p:cNvPr>
          <p:cNvSpPr txBox="1"/>
          <p:nvPr/>
        </p:nvSpPr>
        <p:spPr>
          <a:xfrm>
            <a:off x="522467" y="5696154"/>
            <a:ext cx="827470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P, 5FU+Cisplatin; FN, 5FU+Nedaplatin; PTX, Paclitaxel; CDDP, Cisplatin; NDP, Nedaplatin; DOC, Docetaxel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882975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7185</TotalTime>
  <Words>192</Words>
  <Application>Microsoft Office PowerPoint</Application>
  <PresentationFormat>ワイド画面</PresentationFormat>
  <Paragraphs>10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伊藤 錬磨</dc:creator>
  <cp:lastModifiedBy>Ito Renma</cp:lastModifiedBy>
  <cp:revision>153</cp:revision>
  <dcterms:created xsi:type="dcterms:W3CDTF">2019-02-10T01:09:09Z</dcterms:created>
  <dcterms:modified xsi:type="dcterms:W3CDTF">2022-05-12T07:31:07Z</dcterms:modified>
</cp:coreProperties>
</file>